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8" r:id="rId2"/>
    <p:sldId id="257" r:id="rId3"/>
    <p:sldId id="259" r:id="rId4"/>
    <p:sldId id="261" r:id="rId5"/>
    <p:sldId id="260" r:id="rId6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3" autoAdjust="0"/>
    <p:restoredTop sz="83566" autoAdjust="0"/>
  </p:normalViewPr>
  <p:slideViewPr>
    <p:cSldViewPr snapToGrid="0">
      <p:cViewPr>
        <p:scale>
          <a:sx n="112" d="100"/>
          <a:sy n="112" d="100"/>
        </p:scale>
        <p:origin x="-552" y="-96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F89ABC-A2EF-4D6A-AFE7-AD1A1589583E}" type="datetimeFigureOut">
              <a:rPr lang="ko-KR" altLang="en-US" smtClean="0"/>
              <a:t>2021-12-1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59B254-245C-465F-988E-6DF012E521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08181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/>
              <a:t>Median </a:t>
            </a:r>
          </a:p>
          <a:p>
            <a:r>
              <a:rPr lang="en-US" altLang="ko-KR" dirty="0"/>
              <a:t>Eosinophilic 50.2 years</a:t>
            </a:r>
          </a:p>
          <a:p>
            <a:r>
              <a:rPr lang="en-US" altLang="ko-KR" dirty="0"/>
              <a:t>Non-eosinophilic 49.6 years 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659B254-245C-465F-988E-6DF012E52126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62504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45810E5-B82C-4168-9533-F6513106B2C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DE16E1C9-3B33-4282-A698-42B7A9CEC89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AD8B5F2-43D8-421A-91C6-5A63C3F2E1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E3C3F7-2A76-48EA-BE04-63D980F8BA27}" type="datetimeFigureOut">
              <a:rPr lang="ko-KR" altLang="en-US" smtClean="0"/>
              <a:t>2021-12-1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9C9930F-2BE3-4F1B-9D26-A0954279F9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A656305-DF1A-4444-AC95-2C89C0A1F0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904A5-82D2-42AB-9486-7FF0A1249C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30553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5142184-E296-4B6F-9100-780DA6E486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C9D75C63-D242-4BBA-8E38-B47FE662E6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827C1B1-BB56-4715-9B13-06CD1FF8F6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E3C3F7-2A76-48EA-BE04-63D980F8BA27}" type="datetimeFigureOut">
              <a:rPr lang="ko-KR" altLang="en-US" smtClean="0"/>
              <a:t>2021-12-1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B4BDBE0-7BA7-4960-AF14-690FF82085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755375C-8902-4B9E-B964-04F54712E6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904A5-82D2-42AB-9486-7FF0A1249C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41509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FC3AB8D7-4F4B-40AE-B612-EDFE9A432D9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CF473098-8798-49DF-B17D-3A96CAD0CA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6AC8BB4-9347-4160-BC59-6EBED74C5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E3C3F7-2A76-48EA-BE04-63D980F8BA27}" type="datetimeFigureOut">
              <a:rPr lang="ko-KR" altLang="en-US" smtClean="0"/>
              <a:t>2021-12-1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D571913-CD4C-4950-8E84-F28E197A4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F058C5D-DC60-49B1-B707-4A70917AC5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904A5-82D2-42AB-9486-7FF0A1249C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05734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F466DBF-2546-496E-AA0D-61F8A86E48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A2D3A64-961E-4B67-9885-45D2B7BE3E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511A685-49D9-449C-B77E-F10ECA5552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E3C3F7-2A76-48EA-BE04-63D980F8BA27}" type="datetimeFigureOut">
              <a:rPr lang="ko-KR" altLang="en-US" smtClean="0"/>
              <a:t>2021-12-1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1A4D59D-86F7-4D08-8740-C4F412AB82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121EF55-087D-4304-9AEF-B2563455AE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904A5-82D2-42AB-9486-7FF0A1249C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9910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B165F4F-8EF5-4702-AC2A-E7A195FC61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CE59760-248F-4384-A337-F1AD9C0592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98C633E-635B-4F20-9162-75E8A4FF4E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E3C3F7-2A76-48EA-BE04-63D980F8BA27}" type="datetimeFigureOut">
              <a:rPr lang="ko-KR" altLang="en-US" smtClean="0"/>
              <a:t>2021-12-1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78E4A3F-6E7A-40F5-AE80-0B328CE315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29737FC-48DA-486B-8C29-DCFFFA93A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904A5-82D2-42AB-9486-7FF0A1249C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0343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44DEEF8-BDE2-444A-8C3E-A9AF4987E9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6B95A94-8730-496E-801B-7292587FAC3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146EE8EB-EF1B-4F2A-BB2F-A7F6C9977E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F798C2DC-9CA4-4143-B5A7-EA6E71AB9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E3C3F7-2A76-48EA-BE04-63D980F8BA27}" type="datetimeFigureOut">
              <a:rPr lang="ko-KR" altLang="en-US" smtClean="0"/>
              <a:t>2021-12-13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764A607-5724-4130-8FA6-B2A8C1DEB9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91AD9DD-68B0-43F3-A3D7-B557E33AFD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904A5-82D2-42AB-9486-7FF0A1249C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5739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F7BACD8-D97F-434C-A8D1-3823D74D31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23B8DCE-3701-4CE9-88E8-EDAC28DE95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7AF92B5-E574-41D6-A8B1-87C6737FE4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E42CC358-788E-449B-A1F8-FCD1AD3878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A400E404-95AD-4209-98E4-E13F776DD44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07CDEB22-FF1E-4B07-8A13-C08A23C206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E3C3F7-2A76-48EA-BE04-63D980F8BA27}" type="datetimeFigureOut">
              <a:rPr lang="ko-KR" altLang="en-US" smtClean="0"/>
              <a:t>2021-12-13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F9EA24C5-5BEB-4384-AF75-CFAD076FDC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DE8C351E-2D51-4298-AC38-4EB2C79FA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904A5-82D2-42AB-9486-7FF0A1249C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70766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B100ADA-ADE1-4A1E-86CE-CB065BA773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00B02339-D9CB-4D3A-B55A-A2D0B65037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E3C3F7-2A76-48EA-BE04-63D980F8BA27}" type="datetimeFigureOut">
              <a:rPr lang="ko-KR" altLang="en-US" smtClean="0"/>
              <a:t>2021-12-13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8BCFEB0A-6D04-4F04-848A-193F1E6CD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4D54E439-80B5-4D8B-AE98-A87250413A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904A5-82D2-42AB-9486-7FF0A1249C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80118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CAAEABB5-920F-40BB-9FD0-8D9D047F6F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E3C3F7-2A76-48EA-BE04-63D980F8BA27}" type="datetimeFigureOut">
              <a:rPr lang="ko-KR" altLang="en-US" smtClean="0"/>
              <a:t>2021-12-13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0049B4CE-2A7C-4408-AF8D-6E3160DE48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A1F7B960-ADD5-40B7-8BFB-1F5FC60E47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904A5-82D2-42AB-9486-7FF0A1249C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22322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EE42441-7FDC-4E30-B15D-F7F88B1201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98C6D9B-9557-4050-A0F9-34234E46B4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627826C7-955E-478D-A9D9-D56624CBD6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4635560-764B-41F9-80C3-3C401B87F5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E3C3F7-2A76-48EA-BE04-63D980F8BA27}" type="datetimeFigureOut">
              <a:rPr lang="ko-KR" altLang="en-US" smtClean="0"/>
              <a:t>2021-12-13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0892334-21B1-4004-BD1F-44EFD74DA8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F19018F-6E97-412D-BE1B-CACDDF8A69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904A5-82D2-42AB-9486-7FF0A1249C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19502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577926F-12EB-4856-97C7-EF1D6DD353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20D7E87E-EDE3-411B-85B3-68E80A7DDB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A273196-61DC-4B07-B0C5-33516C66F0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66152D8-5007-4513-AE6C-5FA9DD83C6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E3C3F7-2A76-48EA-BE04-63D980F8BA27}" type="datetimeFigureOut">
              <a:rPr lang="ko-KR" altLang="en-US" smtClean="0"/>
              <a:t>2021-12-13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9E0F501-88C8-4BCD-9C9C-A1C4A28ED6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5CA13D7-FDA7-4E17-B695-D9F8F7969C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904A5-82D2-42AB-9486-7FF0A1249C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4908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66D05FC4-3CA2-436C-B19C-82E106EB37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07E4B37-66C2-400F-9748-340EDEAF44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676D448-8C1C-48C8-A0C1-B73A8EBCC21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E3C3F7-2A76-48EA-BE04-63D980F8BA27}" type="datetimeFigureOut">
              <a:rPr lang="ko-KR" altLang="en-US" smtClean="0"/>
              <a:t>2021-12-1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24A02AF-3C3B-40FF-AB92-B1ACBE3A51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096A209-441A-4B50-87BF-F3BD1DB294B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4904A5-82D2-42AB-9486-7FF0A1249C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48102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5E300D7-6703-4C56-9FBC-BE840F8B0B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  <a:r>
              <a:rPr lang="ko-KR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t</a:t>
            </a:r>
            <a:r>
              <a:rPr lang="ko-KR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f</a:t>
            </a:r>
            <a:r>
              <a:rPr lang="ko-KR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40 years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BFA9041-5E20-470F-BB59-48FF732050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ko-KR" altLang="en-US" dirty="0"/>
          </a:p>
        </p:txBody>
      </p:sp>
      <p:graphicFrame>
        <p:nvGraphicFramePr>
          <p:cNvPr id="4" name="내용 개체 틀 3">
            <a:extLst>
              <a:ext uri="{FF2B5EF4-FFF2-40B4-BE49-F238E27FC236}">
                <a16:creationId xmlns:a16="http://schemas.microsoft.com/office/drawing/2014/main" id="{B866E75B-A597-4AFC-89EB-3ECCE7B4C4C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93876156"/>
              </p:ext>
            </p:extLst>
          </p:nvPr>
        </p:nvGraphicFramePr>
        <p:xfrm>
          <a:off x="930795" y="2128105"/>
          <a:ext cx="9699104" cy="404885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32582">
                  <a:extLst>
                    <a:ext uri="{9D8B030D-6E8A-4147-A177-3AD203B41FA5}">
                      <a16:colId xmlns:a16="http://schemas.microsoft.com/office/drawing/2014/main" val="4048299689"/>
                    </a:ext>
                  </a:extLst>
                </a:gridCol>
                <a:gridCol w="1460306">
                  <a:extLst>
                    <a:ext uri="{9D8B030D-6E8A-4147-A177-3AD203B41FA5}">
                      <a16:colId xmlns:a16="http://schemas.microsoft.com/office/drawing/2014/main" val="144299765"/>
                    </a:ext>
                  </a:extLst>
                </a:gridCol>
                <a:gridCol w="1460306">
                  <a:extLst>
                    <a:ext uri="{9D8B030D-6E8A-4147-A177-3AD203B41FA5}">
                      <a16:colId xmlns:a16="http://schemas.microsoft.com/office/drawing/2014/main" val="1099183481"/>
                    </a:ext>
                  </a:extLst>
                </a:gridCol>
                <a:gridCol w="1493724">
                  <a:extLst>
                    <a:ext uri="{9D8B030D-6E8A-4147-A177-3AD203B41FA5}">
                      <a16:colId xmlns:a16="http://schemas.microsoft.com/office/drawing/2014/main" val="3099500036"/>
                    </a:ext>
                  </a:extLst>
                </a:gridCol>
                <a:gridCol w="1493724">
                  <a:extLst>
                    <a:ext uri="{9D8B030D-6E8A-4147-A177-3AD203B41FA5}">
                      <a16:colId xmlns:a16="http://schemas.microsoft.com/office/drawing/2014/main" val="3239785279"/>
                    </a:ext>
                  </a:extLst>
                </a:gridCol>
                <a:gridCol w="1493724">
                  <a:extLst>
                    <a:ext uri="{9D8B030D-6E8A-4147-A177-3AD203B41FA5}">
                      <a16:colId xmlns:a16="http://schemas.microsoft.com/office/drawing/2014/main" val="1252535265"/>
                    </a:ext>
                  </a:extLst>
                </a:gridCol>
                <a:gridCol w="764738">
                  <a:extLst>
                    <a:ext uri="{9D8B030D-6E8A-4147-A177-3AD203B41FA5}">
                      <a16:colId xmlns:a16="http://schemas.microsoft.com/office/drawing/2014/main" val="3273936516"/>
                    </a:ext>
                  </a:extLst>
                </a:gridCol>
              </a:tblGrid>
              <a:tr h="259917">
                <a:tc rowSpan="2"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nical characteristics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osinophilic </a:t>
                      </a:r>
                      <a:r>
                        <a:rPr lang="en-US" sz="10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SwNP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eosinophilic CRSwNP 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05648922"/>
                  </a:ext>
                </a:extLst>
              </a:tr>
              <a:tr h="839615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ounger age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25)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lder age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81)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ounger age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47)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lder age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116)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31753066"/>
                  </a:ext>
                </a:extLst>
              </a:tr>
              <a:tr h="380963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(years)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3.4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7.1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4.6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8.2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3.7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9.4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6.9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9.7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58780528"/>
                  </a:ext>
                </a:extLst>
              </a:tr>
              <a:tr h="380963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M score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4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2.6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0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3.7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39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8.0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5.2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3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4.3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6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0856941"/>
                  </a:ext>
                </a:extLst>
              </a:tr>
              <a:tr h="663549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ood eosinophil (%)</a:t>
                      </a:r>
                      <a:endParaRPr lang="ko-KR" sz="10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.4</a:t>
                      </a:r>
                      <a:r>
                        <a:rPr lang="en-US" altLang="ko-KR" sz="10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4.1</a:t>
                      </a:r>
                      <a:endParaRPr lang="ko-KR" sz="10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8</a:t>
                      </a:r>
                      <a:r>
                        <a:rPr lang="en-US" altLang="ko-KR" sz="10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4.1</a:t>
                      </a:r>
                      <a:endParaRPr lang="ko-KR" sz="10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22</a:t>
                      </a:r>
                      <a:endParaRPr lang="ko-KR" sz="10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7</a:t>
                      </a:r>
                      <a:r>
                        <a:rPr lang="en-US" altLang="ko-KR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3.4</a:t>
                      </a:r>
                      <a:endParaRPr lang="ko-KR" sz="10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4</a:t>
                      </a:r>
                      <a:r>
                        <a:rPr lang="en-US" altLang="ko-KR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5.1</a:t>
                      </a:r>
                      <a:endParaRPr lang="ko-KR" sz="10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36</a:t>
                      </a:r>
                      <a:endParaRPr lang="ko-KR" sz="10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39709610"/>
                  </a:ext>
                </a:extLst>
              </a:tr>
              <a:tr h="380963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thma (%) 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0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.2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02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.8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.1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97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79229303"/>
                  </a:ext>
                </a:extLst>
              </a:tr>
              <a:tr h="380963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K 3</a:t>
                      </a:r>
                      <a:endParaRPr lang="ko-KR" sz="10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2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2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77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6</a:t>
                      </a:r>
                      <a:r>
                        <a:rPr lang="en-US" altLang="ko-KR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2.5</a:t>
                      </a:r>
                      <a:endParaRPr lang="ko-KR" sz="10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</a:t>
                      </a:r>
                      <a:r>
                        <a:rPr lang="en-US" altLang="ko-KR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7</a:t>
                      </a:r>
                      <a:endParaRPr lang="ko-KR" sz="10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05</a:t>
                      </a:r>
                      <a:endParaRPr lang="ko-KR" sz="10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668262"/>
                  </a:ext>
                </a:extLst>
              </a:tr>
              <a:tr h="380963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K 6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5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3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2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86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5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2.0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8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55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9006865"/>
                  </a:ext>
                </a:extLst>
              </a:tr>
              <a:tr h="380963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K 12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4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4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16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2.5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1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2.3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81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948739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162007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1B7FEC4-0B0A-4E20-B71B-B1073995E5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  <a:r>
              <a:rPr lang="ko-KR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t</a:t>
            </a:r>
            <a:r>
              <a:rPr lang="ko-KR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f</a:t>
            </a:r>
            <a:r>
              <a:rPr lang="ko-KR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median age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내용 개체 틀 3">
            <a:extLst>
              <a:ext uri="{FF2B5EF4-FFF2-40B4-BE49-F238E27FC236}">
                <a16:creationId xmlns:a16="http://schemas.microsoft.com/office/drawing/2014/main" id="{EAD3E845-DFC2-4254-B573-531FA46142ED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246008949"/>
              </p:ext>
            </p:extLst>
          </p:nvPr>
        </p:nvGraphicFramePr>
        <p:xfrm>
          <a:off x="519545" y="1690688"/>
          <a:ext cx="10713028" cy="437760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92795">
                  <a:extLst>
                    <a:ext uri="{9D8B030D-6E8A-4147-A177-3AD203B41FA5}">
                      <a16:colId xmlns:a16="http://schemas.microsoft.com/office/drawing/2014/main" val="4048299689"/>
                    </a:ext>
                  </a:extLst>
                </a:gridCol>
                <a:gridCol w="1612963">
                  <a:extLst>
                    <a:ext uri="{9D8B030D-6E8A-4147-A177-3AD203B41FA5}">
                      <a16:colId xmlns:a16="http://schemas.microsoft.com/office/drawing/2014/main" val="144299765"/>
                    </a:ext>
                  </a:extLst>
                </a:gridCol>
                <a:gridCol w="1612963">
                  <a:extLst>
                    <a:ext uri="{9D8B030D-6E8A-4147-A177-3AD203B41FA5}">
                      <a16:colId xmlns:a16="http://schemas.microsoft.com/office/drawing/2014/main" val="1099183481"/>
                    </a:ext>
                  </a:extLst>
                </a:gridCol>
                <a:gridCol w="1649875">
                  <a:extLst>
                    <a:ext uri="{9D8B030D-6E8A-4147-A177-3AD203B41FA5}">
                      <a16:colId xmlns:a16="http://schemas.microsoft.com/office/drawing/2014/main" val="3099500036"/>
                    </a:ext>
                  </a:extLst>
                </a:gridCol>
                <a:gridCol w="1649875">
                  <a:extLst>
                    <a:ext uri="{9D8B030D-6E8A-4147-A177-3AD203B41FA5}">
                      <a16:colId xmlns:a16="http://schemas.microsoft.com/office/drawing/2014/main" val="3239785279"/>
                    </a:ext>
                  </a:extLst>
                </a:gridCol>
                <a:gridCol w="1649875">
                  <a:extLst>
                    <a:ext uri="{9D8B030D-6E8A-4147-A177-3AD203B41FA5}">
                      <a16:colId xmlns:a16="http://schemas.microsoft.com/office/drawing/2014/main" val="1252535265"/>
                    </a:ext>
                  </a:extLst>
                </a:gridCol>
                <a:gridCol w="844682">
                  <a:extLst>
                    <a:ext uri="{9D8B030D-6E8A-4147-A177-3AD203B41FA5}">
                      <a16:colId xmlns:a16="http://schemas.microsoft.com/office/drawing/2014/main" val="3273936516"/>
                    </a:ext>
                  </a:extLst>
                </a:gridCol>
              </a:tblGrid>
              <a:tr h="281021">
                <a:tc rowSpan="2"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nical characteristics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osinophilic CRSwNP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eosinophilic </a:t>
                      </a:r>
                      <a:r>
                        <a:rPr lang="en-US" sz="10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SwNP</a:t>
                      </a: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05648922"/>
                  </a:ext>
                </a:extLst>
              </a:tr>
              <a:tr h="90778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ounger age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53)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lder age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53)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ounger age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82)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lder age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81)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31753066"/>
                  </a:ext>
                </a:extLst>
              </a:tr>
              <a:tr h="411895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(years)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0.1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8.2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9.1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6.3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2.7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2.7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2.2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6.3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58780528"/>
                  </a:ext>
                </a:extLst>
              </a:tr>
              <a:tr h="411895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M score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7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3.2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1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3.7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37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5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4.5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5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4.7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25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0856941"/>
                  </a:ext>
                </a:extLst>
              </a:tr>
              <a:tr h="717425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ood eosinophil (%)</a:t>
                      </a:r>
                      <a:endParaRPr lang="ko-KR" sz="10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.6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4.1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3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3.9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03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1</a:t>
                      </a:r>
                      <a:r>
                        <a:rPr lang="en-US" altLang="ko-KR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3.6</a:t>
                      </a:r>
                      <a:endParaRPr lang="ko-KR" sz="10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7</a:t>
                      </a:r>
                      <a:r>
                        <a:rPr lang="en-US" altLang="ko-KR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5.6</a:t>
                      </a:r>
                      <a:endParaRPr lang="ko-KR" sz="10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33</a:t>
                      </a:r>
                      <a:endParaRPr lang="ko-KR" sz="10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39709610"/>
                  </a:ext>
                </a:extLst>
              </a:tr>
              <a:tr h="411895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thma (%) 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0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4.5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38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.4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.9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82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79229303"/>
                  </a:ext>
                </a:extLst>
              </a:tr>
              <a:tr h="411895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K 3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2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3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59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2.2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9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61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668262"/>
                  </a:ext>
                </a:extLst>
              </a:tr>
              <a:tr h="411895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K 6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3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1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21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1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8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5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9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77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9006865"/>
                  </a:ext>
                </a:extLst>
              </a:tr>
              <a:tr h="411895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K 12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3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5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03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2.1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8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2.7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10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948739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697169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E0ACD11-4E61-4DB7-9E91-4E13E1CC1B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  <a:r>
              <a:rPr lang="ko-KR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t</a:t>
            </a:r>
            <a:r>
              <a:rPr lang="ko-KR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f</a:t>
            </a:r>
            <a:r>
              <a:rPr lang="ko-KR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60 years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381655B-B82B-4073-B9FC-F72F1F1142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내용 개체 틀 3">
            <a:extLst>
              <a:ext uri="{FF2B5EF4-FFF2-40B4-BE49-F238E27FC236}">
                <a16:creationId xmlns:a16="http://schemas.microsoft.com/office/drawing/2014/main" id="{580864B0-FA69-4D0A-BF8D-60349A4A7C2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55550394"/>
              </p:ext>
            </p:extLst>
          </p:nvPr>
        </p:nvGraphicFramePr>
        <p:xfrm>
          <a:off x="930795" y="2057400"/>
          <a:ext cx="10799994" cy="392229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06537">
                  <a:extLst>
                    <a:ext uri="{9D8B030D-6E8A-4147-A177-3AD203B41FA5}">
                      <a16:colId xmlns:a16="http://schemas.microsoft.com/office/drawing/2014/main" val="4048299689"/>
                    </a:ext>
                  </a:extLst>
                </a:gridCol>
                <a:gridCol w="1626057">
                  <a:extLst>
                    <a:ext uri="{9D8B030D-6E8A-4147-A177-3AD203B41FA5}">
                      <a16:colId xmlns:a16="http://schemas.microsoft.com/office/drawing/2014/main" val="144299765"/>
                    </a:ext>
                  </a:extLst>
                </a:gridCol>
                <a:gridCol w="1626057">
                  <a:extLst>
                    <a:ext uri="{9D8B030D-6E8A-4147-A177-3AD203B41FA5}">
                      <a16:colId xmlns:a16="http://schemas.microsoft.com/office/drawing/2014/main" val="1099183481"/>
                    </a:ext>
                  </a:extLst>
                </a:gridCol>
                <a:gridCol w="1663268">
                  <a:extLst>
                    <a:ext uri="{9D8B030D-6E8A-4147-A177-3AD203B41FA5}">
                      <a16:colId xmlns:a16="http://schemas.microsoft.com/office/drawing/2014/main" val="3099500036"/>
                    </a:ext>
                  </a:extLst>
                </a:gridCol>
                <a:gridCol w="1663268">
                  <a:extLst>
                    <a:ext uri="{9D8B030D-6E8A-4147-A177-3AD203B41FA5}">
                      <a16:colId xmlns:a16="http://schemas.microsoft.com/office/drawing/2014/main" val="3239785279"/>
                    </a:ext>
                  </a:extLst>
                </a:gridCol>
                <a:gridCol w="1663268">
                  <a:extLst>
                    <a:ext uri="{9D8B030D-6E8A-4147-A177-3AD203B41FA5}">
                      <a16:colId xmlns:a16="http://schemas.microsoft.com/office/drawing/2014/main" val="1252535265"/>
                    </a:ext>
                  </a:extLst>
                </a:gridCol>
                <a:gridCol w="851539">
                  <a:extLst>
                    <a:ext uri="{9D8B030D-6E8A-4147-A177-3AD203B41FA5}">
                      <a16:colId xmlns:a16="http://schemas.microsoft.com/office/drawing/2014/main" val="3273936516"/>
                    </a:ext>
                  </a:extLst>
                </a:gridCol>
              </a:tblGrid>
              <a:tr h="314790">
                <a:tc rowSpan="2"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nical characteristics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osinophilic </a:t>
                      </a:r>
                      <a:r>
                        <a:rPr lang="en-US" sz="10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SwNP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eosinophilic </a:t>
                      </a:r>
                      <a:r>
                        <a:rPr lang="en-US" sz="10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SwNP</a:t>
                      </a: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05648922"/>
                  </a:ext>
                </a:extLst>
              </a:tr>
              <a:tr h="79940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ounger age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86)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lder age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20)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ounger age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112)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lder age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51)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31753066"/>
                  </a:ext>
                </a:extLst>
              </a:tr>
              <a:tr h="362720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(years)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5.8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9.9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6.0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3.9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9.1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5.2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5.6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5.2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58780528"/>
                  </a:ext>
                </a:extLst>
              </a:tr>
              <a:tr h="362720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M score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9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3.5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9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3.2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63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6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4.5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2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4.6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66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0856941"/>
                  </a:ext>
                </a:extLst>
              </a:tr>
              <a:tr h="631774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ood eosinophil (%)</a:t>
                      </a:r>
                      <a:endParaRPr lang="ko-KR" sz="10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9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4.1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.1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4.1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77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3</a:t>
                      </a:r>
                      <a:r>
                        <a:rPr lang="en-US" altLang="ko-KR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3.6</a:t>
                      </a:r>
                      <a:endParaRPr lang="ko-KR" sz="10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2</a:t>
                      </a:r>
                      <a:r>
                        <a:rPr lang="en-US" altLang="ko-KR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6.4</a:t>
                      </a:r>
                      <a:endParaRPr lang="ko-KR" sz="10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16</a:t>
                      </a:r>
                      <a:endParaRPr lang="ko-KR" sz="10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39709610"/>
                  </a:ext>
                </a:extLst>
              </a:tr>
              <a:tr h="362720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thma (%) 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4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5.0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81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.4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8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06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79229303"/>
                  </a:ext>
                </a:extLst>
              </a:tr>
              <a:tr h="362720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K 3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3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3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2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63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2.1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8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36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668262"/>
                  </a:ext>
                </a:extLst>
              </a:tr>
              <a:tr h="362720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K 6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3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5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2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24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8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2.0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50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9006865"/>
                  </a:ext>
                </a:extLst>
              </a:tr>
              <a:tr h="362720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K 12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3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8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70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9850" marR="69850" marT="34925" marB="3492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2.1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1</a:t>
                      </a: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3.1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00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948739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928142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9815682-E938-4630-8FA5-ACADCA4CB4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kine comparison according to different age criteria (Control vs E-Y vs E-O)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내용 개체 틀 3">
            <a:extLst>
              <a:ext uri="{FF2B5EF4-FFF2-40B4-BE49-F238E27FC236}">
                <a16:creationId xmlns:a16="http://schemas.microsoft.com/office/drawing/2014/main" id="{53A95CB2-9CA6-467F-90B0-21708F3BA490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915231907"/>
              </p:ext>
            </p:extLst>
          </p:nvPr>
        </p:nvGraphicFramePr>
        <p:xfrm>
          <a:off x="1336964" y="1658072"/>
          <a:ext cx="8659092" cy="4834803"/>
        </p:xfrm>
        <a:graphic>
          <a:graphicData uri="http://schemas.openxmlformats.org/drawingml/2006/table">
            <a:tbl>
              <a:tblPr/>
              <a:tblGrid>
                <a:gridCol w="2164773">
                  <a:extLst>
                    <a:ext uri="{9D8B030D-6E8A-4147-A177-3AD203B41FA5}">
                      <a16:colId xmlns:a16="http://schemas.microsoft.com/office/drawing/2014/main" val="602801319"/>
                    </a:ext>
                  </a:extLst>
                </a:gridCol>
                <a:gridCol w="2164773">
                  <a:extLst>
                    <a:ext uri="{9D8B030D-6E8A-4147-A177-3AD203B41FA5}">
                      <a16:colId xmlns:a16="http://schemas.microsoft.com/office/drawing/2014/main" val="3777542229"/>
                    </a:ext>
                  </a:extLst>
                </a:gridCol>
                <a:gridCol w="2164773">
                  <a:extLst>
                    <a:ext uri="{9D8B030D-6E8A-4147-A177-3AD203B41FA5}">
                      <a16:colId xmlns:a16="http://schemas.microsoft.com/office/drawing/2014/main" val="4008753983"/>
                    </a:ext>
                  </a:extLst>
                </a:gridCol>
                <a:gridCol w="2164773">
                  <a:extLst>
                    <a:ext uri="{9D8B030D-6E8A-4147-A177-3AD203B41FA5}">
                      <a16:colId xmlns:a16="http://schemas.microsoft.com/office/drawing/2014/main" val="3372514643"/>
                    </a:ext>
                  </a:extLst>
                </a:gridCol>
              </a:tblGrid>
              <a:tr h="33723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ytokine</a:t>
                      </a:r>
                    </a:p>
                  </a:txBody>
                  <a:tcPr marL="6243" marR="6243" marT="624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djusted P-values</a:t>
                      </a:r>
                    </a:p>
                  </a:txBody>
                  <a:tcPr marL="6243" marR="6243" marT="624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djusted p-values (40)</a:t>
                      </a:r>
                    </a:p>
                  </a:txBody>
                  <a:tcPr marL="6243" marR="6243" marT="624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djusted p-values (60)</a:t>
                      </a:r>
                    </a:p>
                  </a:txBody>
                  <a:tcPr marL="6243" marR="6243" marT="624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0063555"/>
                  </a:ext>
                </a:extLst>
              </a:tr>
              <a:tr h="337238">
                <a:tc vMerge="1"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43" marR="6243" marT="624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edian age 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ge 40 years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ge 60 years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428356"/>
                  </a:ext>
                </a:extLst>
              </a:tr>
              <a:tr h="2913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1AT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1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0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8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3812742"/>
                  </a:ext>
                </a:extLst>
              </a:tr>
              <a:tr h="2913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GF-b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2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2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3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4518249"/>
                  </a:ext>
                </a:extLst>
              </a:tr>
              <a:tr h="2913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PO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1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9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3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3418125"/>
                  </a:ext>
                </a:extLst>
              </a:tr>
              <a:tr h="2913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L2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7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0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8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9508554"/>
                  </a:ext>
                </a:extLst>
              </a:tr>
              <a:tr h="37641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IP1b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3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1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8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7763946"/>
                  </a:ext>
                </a:extLst>
              </a:tr>
              <a:tr h="2913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FNr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6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6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8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5658419"/>
                  </a:ext>
                </a:extLst>
              </a:tr>
              <a:tr h="2913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L1b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3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7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8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3730425"/>
                  </a:ext>
                </a:extLst>
              </a:tr>
              <a:tr h="2913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L1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6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1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8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6320893"/>
                  </a:ext>
                </a:extLst>
              </a:tr>
              <a:tr h="2913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L3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0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7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9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9265586"/>
                  </a:ext>
                </a:extLst>
              </a:tr>
              <a:tr h="2913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L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1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1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1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1897855"/>
                  </a:ext>
                </a:extLst>
              </a:tr>
              <a:tr h="2913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L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9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5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4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6381950"/>
                  </a:ext>
                </a:extLst>
              </a:tr>
              <a:tr h="2913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L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3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5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3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1452878"/>
                  </a:ext>
                </a:extLst>
              </a:tr>
              <a:tr h="2913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NF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4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1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8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3406342"/>
                  </a:ext>
                </a:extLst>
              </a:tr>
              <a:tr h="28770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N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7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1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8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52743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015930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CF5850C-9BE9-4312-BE5D-351F806C59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kine comparison according to different age criteria (Control vs NE-Y vs NE-O)</a:t>
            </a:r>
            <a:endParaRPr lang="ko-KR" altLang="en-US" dirty="0"/>
          </a:p>
        </p:txBody>
      </p:sp>
      <p:graphicFrame>
        <p:nvGraphicFramePr>
          <p:cNvPr id="4" name="내용 개체 틀 3">
            <a:extLst>
              <a:ext uri="{FF2B5EF4-FFF2-40B4-BE49-F238E27FC236}">
                <a16:creationId xmlns:a16="http://schemas.microsoft.com/office/drawing/2014/main" id="{FA6D6D86-B767-42D7-8DAB-AB60CBE9E602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525823037"/>
              </p:ext>
            </p:extLst>
          </p:nvPr>
        </p:nvGraphicFramePr>
        <p:xfrm>
          <a:off x="1193465" y="1771650"/>
          <a:ext cx="9103924" cy="4120000"/>
        </p:xfrm>
        <a:graphic>
          <a:graphicData uri="http://schemas.openxmlformats.org/drawingml/2006/table">
            <a:tbl>
              <a:tblPr/>
              <a:tblGrid>
                <a:gridCol w="2275981">
                  <a:extLst>
                    <a:ext uri="{9D8B030D-6E8A-4147-A177-3AD203B41FA5}">
                      <a16:colId xmlns:a16="http://schemas.microsoft.com/office/drawing/2014/main" val="3075278020"/>
                    </a:ext>
                  </a:extLst>
                </a:gridCol>
                <a:gridCol w="2275981">
                  <a:extLst>
                    <a:ext uri="{9D8B030D-6E8A-4147-A177-3AD203B41FA5}">
                      <a16:colId xmlns:a16="http://schemas.microsoft.com/office/drawing/2014/main" val="4015741181"/>
                    </a:ext>
                  </a:extLst>
                </a:gridCol>
                <a:gridCol w="2275981">
                  <a:extLst>
                    <a:ext uri="{9D8B030D-6E8A-4147-A177-3AD203B41FA5}">
                      <a16:colId xmlns:a16="http://schemas.microsoft.com/office/drawing/2014/main" val="4082196716"/>
                    </a:ext>
                  </a:extLst>
                </a:gridCol>
                <a:gridCol w="2275981">
                  <a:extLst>
                    <a:ext uri="{9D8B030D-6E8A-4147-A177-3AD203B41FA5}">
                      <a16:colId xmlns:a16="http://schemas.microsoft.com/office/drawing/2014/main" val="1364636494"/>
                    </a:ext>
                  </a:extLst>
                </a:gridCol>
              </a:tblGrid>
              <a:tr h="2575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ytokine</a:t>
                      </a:r>
                      <a:endParaRPr lang="ko-KR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djusted P-values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ge 40 years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ge 60 years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4920190"/>
                  </a:ext>
                </a:extLst>
              </a:tr>
              <a:tr h="257500">
                <a:tc vMerge="1">
                  <a:txBody>
                    <a:bodyPr/>
                    <a:lstStyle/>
                    <a:p>
                      <a:pPr algn="ctr" fontAlgn="ctr"/>
                      <a:endParaRPr lang="ko-KR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edian age 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ge 40 years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ge 60 years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776877"/>
                  </a:ext>
                </a:extLst>
              </a:tr>
              <a:tr h="257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1AT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7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1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2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0504558"/>
                  </a:ext>
                </a:extLst>
              </a:tr>
              <a:tr h="257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GF-b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3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3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3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028080"/>
                  </a:ext>
                </a:extLst>
              </a:tr>
              <a:tr h="257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PO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8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0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0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8057723"/>
                  </a:ext>
                </a:extLst>
              </a:tr>
              <a:tr h="257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L2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4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9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4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7213002"/>
                  </a:ext>
                </a:extLst>
              </a:tr>
              <a:tr h="257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IP1b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8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4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0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6825400"/>
                  </a:ext>
                </a:extLst>
              </a:tr>
              <a:tr h="257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FNr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4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5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6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6772935"/>
                  </a:ext>
                </a:extLst>
              </a:tr>
              <a:tr h="257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L1b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3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2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3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6421405"/>
                  </a:ext>
                </a:extLst>
              </a:tr>
              <a:tr h="257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L1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8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1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6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5414716"/>
                  </a:ext>
                </a:extLst>
              </a:tr>
              <a:tr h="257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L3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6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9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8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6945380"/>
                  </a:ext>
                </a:extLst>
              </a:tr>
              <a:tr h="257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L5*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19</a:t>
                      </a:r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</a:t>
                      </a:r>
                      <a:endParaRPr lang="en-US" altLang="ko-K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09</a:t>
                      </a:r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</a:t>
                      </a:r>
                      <a:endParaRPr lang="en-US" altLang="ko-K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14</a:t>
                      </a:r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</a:t>
                      </a:r>
                      <a:endParaRPr lang="en-US" altLang="ko-K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5265027"/>
                  </a:ext>
                </a:extLst>
              </a:tr>
              <a:tr h="257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L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0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0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0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3250437"/>
                  </a:ext>
                </a:extLst>
              </a:tr>
              <a:tr h="257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L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0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0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0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2603655"/>
                  </a:ext>
                </a:extLst>
              </a:tr>
              <a:tr h="257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NF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1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4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4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4619845"/>
                  </a:ext>
                </a:extLst>
              </a:tr>
              <a:tr h="257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N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0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0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4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1701206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0564C295-FE61-460A-AC90-BA9FE7014109}"/>
              </a:ext>
            </a:extLst>
          </p:cNvPr>
          <p:cNvSpPr txBox="1"/>
          <p:nvPr/>
        </p:nvSpPr>
        <p:spPr>
          <a:xfrm>
            <a:off x="927389" y="6226525"/>
            <a:ext cx="60942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b="1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* p&lt;0.05 for NE-Y vs NE-O</a:t>
            </a:r>
            <a:r>
              <a:rPr lang="en-US" altLang="ko-KR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8055496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4</TotalTime>
  <Words>491</Words>
  <Application>Microsoft Office PowerPoint</Application>
  <PresentationFormat>와이드스크린</PresentationFormat>
  <Paragraphs>318</Paragraphs>
  <Slides>5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9" baseType="lpstr">
      <vt:lpstr>맑은 고딕</vt:lpstr>
      <vt:lpstr>Arial</vt:lpstr>
      <vt:lpstr>Times New Roman</vt:lpstr>
      <vt:lpstr>Office 테마</vt:lpstr>
      <vt:lpstr>Age cut off : 40 years </vt:lpstr>
      <vt:lpstr>Age cut off : median age</vt:lpstr>
      <vt:lpstr>Age cut off : 60 years</vt:lpstr>
      <vt:lpstr>Cytokine comparison according to different age criteria (Control vs E-Y vs E-O)</vt:lpstr>
      <vt:lpstr>Cytokine comparison according to different age criteria (Control vs NE-Y vs NE-O)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.</dc:creator>
  <cp:lastModifiedBy>.</cp:lastModifiedBy>
  <cp:revision>3</cp:revision>
  <dcterms:created xsi:type="dcterms:W3CDTF">2021-12-12T16:50:08Z</dcterms:created>
  <dcterms:modified xsi:type="dcterms:W3CDTF">2021-12-13T13:34:55Z</dcterms:modified>
</cp:coreProperties>
</file>